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AF15D5-B14A-495C-A6AE-40FAAB09F35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9FFAC9-7732-4A47-BACA-475F5FEC5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676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777875" y="1200150"/>
            <a:ext cx="5759450" cy="32400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one more detailed with in and ex viv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872F96-EA7C-4941-A4E1-204FA6C31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1213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E4C1B-FA39-431D-ACE2-DBBB14598F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D51D2A6-F5DC-442F-A0D8-E4B37D3559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2AEEF0-ECA3-4F3B-B28C-C15ED7CCA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F6252D-D92A-4BF1-8BFD-FF2492A87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2D8598-F002-4536-9E64-92FC8B90F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397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0BE64-578E-4388-9069-EE838F954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DF507A-7FCD-4F2A-985E-A3C654825B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3FA75F-90E6-4075-976C-5FBE82FF8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1ABD7-ACA8-4DA7-AE1D-894A486BF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075268-CA3C-4C55-A4D5-09ABE552D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289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78A381-0CEC-4014-9588-C6A0E1A54E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7717C8-E321-4E13-8AD9-2047D8381C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A4F5AA-CD7D-4753-99DC-31CD24D9A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188F0-4484-4276-B144-FD279502D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860552-A943-4F65-A16A-E7D3A4C5D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062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3F5479-72E9-4542-8017-55B669719A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038DD2-0A67-4803-8C4B-F0071E1E13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0AC7A6-7F64-42FC-8158-4B8F77D77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7F8AA3-C681-4377-94DB-0F12DF9F4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980039-C827-44ED-9E05-FF4EF4BB8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956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A12CA-6148-4C47-A2A3-7EC8B15B5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D4F883-576C-4FD1-8454-FC09DB05E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5DFA23-8AF8-4F9D-9035-1E1CF2B98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70CF7F-0EBB-407A-AA0A-6879DEAB2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2C09AE-CD9E-42B9-9A8A-2EECBF01A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12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1925F-E82B-4A77-A08A-62E7AECC65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858F7C-3C5B-4FA8-8D4F-0415E5184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32FA34-48C8-41B7-828B-A120BF94D3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E4F340-DC4A-4CA3-9932-F199BBA91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1C474C-C686-4338-A763-FA9A7CC9A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B0E7F8-2B76-4B74-B7D6-BFD38BEF0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642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E3330B-494C-4885-8C86-DA9C11B925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305B78-CD27-4347-96B6-DC72101AF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DEBBED-31A2-464D-8D00-91C5CEDCE6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B4B67C-974E-4CA7-B5E7-088380D822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D72DA2-9276-4EAE-BC30-F08F0B5599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515B7FD-A5DB-4415-AAB6-0DCB57DED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42E97-E0FA-45EE-AFB9-D445CDA6A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C0DC33-ABDE-4332-A5D8-3A4A8A9E4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43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B0D57-895C-4ACD-AFF6-A9D99CC697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C45CEB-721A-464D-ADA5-7ED6DCB0D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D15C72-D6FB-4C81-8B87-1D1CA8DEA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CC56F5-134F-443A-93BC-06DE07897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53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56FA6F-C422-4A94-95AB-17553E415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C7268E-FA3D-4660-88B3-6A2D78FAC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EC4508-3219-4CA0-89B6-997C3BCFF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662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226D8-53E1-40B8-A587-DC2C1B7F6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3B6FEF-9E74-4367-801F-98794F2F26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C13E45-AA73-4445-9EF1-B33C2E7F25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308471-F733-4806-8DAF-A8708766F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A8DFCD-F6A7-4388-9C71-849EB4BAD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4D857B-67F9-46C9-89D4-46A081A41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453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DB1614-0C68-47DA-9419-6AA5624C0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5704FE-1D0D-41E9-9DA2-F774552721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16794E-D58B-49F2-A858-3BF3C168D3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8DF8D6-8C88-420C-AA8B-0BD4FBA3B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B31DA1-B35D-4CE3-8925-402E60D51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5A3D40-19EE-4C14-848E-02AF03352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98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DD04B0-D71A-4741-80C2-E881D887F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B549C9-1620-4D35-B83C-4666E59F09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E37BB5-FD7B-4CD9-9852-DF965D5681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2BD73-76AB-49CC-B333-893D71C90457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0E60B5-A7A7-40BB-9007-60A80D0ED6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1C6DE0-3E29-4EBD-AF79-598029711D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C5FC8-D3C6-4A08-AA81-60E94ED3D4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279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9" Type="http://schemas.openxmlformats.org/officeDocument/2006/relationships/image" Target="../media/image37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34" Type="http://schemas.openxmlformats.org/officeDocument/2006/relationships/image" Target="../media/image32.jpeg"/><Relationship Id="rId42" Type="http://schemas.openxmlformats.org/officeDocument/2006/relationships/image" Target="../media/image40.jpeg"/><Relationship Id="rId47" Type="http://schemas.openxmlformats.org/officeDocument/2006/relationships/image" Target="../media/image45.jpeg"/><Relationship Id="rId50" Type="http://schemas.openxmlformats.org/officeDocument/2006/relationships/image" Target="../media/image48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33" Type="http://schemas.openxmlformats.org/officeDocument/2006/relationships/image" Target="../media/image31.jpeg"/><Relationship Id="rId38" Type="http://schemas.openxmlformats.org/officeDocument/2006/relationships/image" Target="../media/image36.jpeg"/><Relationship Id="rId46" Type="http://schemas.openxmlformats.org/officeDocument/2006/relationships/image" Target="../media/image44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41" Type="http://schemas.openxmlformats.org/officeDocument/2006/relationships/image" Target="../media/image3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32" Type="http://schemas.openxmlformats.org/officeDocument/2006/relationships/image" Target="../media/image30.jpeg"/><Relationship Id="rId37" Type="http://schemas.openxmlformats.org/officeDocument/2006/relationships/image" Target="../media/image35.jpeg"/><Relationship Id="rId40" Type="http://schemas.openxmlformats.org/officeDocument/2006/relationships/image" Target="../media/image38.jpeg"/><Relationship Id="rId45" Type="http://schemas.openxmlformats.org/officeDocument/2006/relationships/image" Target="../media/image43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36" Type="http://schemas.openxmlformats.org/officeDocument/2006/relationships/image" Target="../media/image34.jpeg"/><Relationship Id="rId49" Type="http://schemas.openxmlformats.org/officeDocument/2006/relationships/image" Target="../media/image47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31" Type="http://schemas.openxmlformats.org/officeDocument/2006/relationships/image" Target="../media/image29.jpeg"/><Relationship Id="rId44" Type="http://schemas.openxmlformats.org/officeDocument/2006/relationships/image" Target="../media/image42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Relationship Id="rId35" Type="http://schemas.openxmlformats.org/officeDocument/2006/relationships/image" Target="../media/image33.jpeg"/><Relationship Id="rId43" Type="http://schemas.openxmlformats.org/officeDocument/2006/relationships/image" Target="../media/image41.jpeg"/><Relationship Id="rId48" Type="http://schemas.openxmlformats.org/officeDocument/2006/relationships/image" Target="../media/image46.jpeg"/><Relationship Id="rId8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7315586"/>
              </p:ext>
            </p:extLst>
          </p:nvPr>
        </p:nvGraphicFramePr>
        <p:xfrm>
          <a:off x="1090610" y="390525"/>
          <a:ext cx="9491356" cy="458628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52562">
                  <a:extLst>
                    <a:ext uri="{9D8B030D-6E8A-4147-A177-3AD203B41FA5}">
                      <a16:colId xmlns:a16="http://schemas.microsoft.com/office/drawing/2014/main" val="3020974570"/>
                    </a:ext>
                  </a:extLst>
                </a:gridCol>
                <a:gridCol w="1685334">
                  <a:extLst>
                    <a:ext uri="{9D8B030D-6E8A-4147-A177-3AD203B41FA5}">
                      <a16:colId xmlns:a16="http://schemas.microsoft.com/office/drawing/2014/main" val="3078550569"/>
                    </a:ext>
                  </a:extLst>
                </a:gridCol>
                <a:gridCol w="2112642">
                  <a:extLst>
                    <a:ext uri="{9D8B030D-6E8A-4147-A177-3AD203B41FA5}">
                      <a16:colId xmlns:a16="http://schemas.microsoft.com/office/drawing/2014/main" val="205561854"/>
                    </a:ext>
                  </a:extLst>
                </a:gridCol>
                <a:gridCol w="2117820">
                  <a:extLst>
                    <a:ext uri="{9D8B030D-6E8A-4147-A177-3AD203B41FA5}">
                      <a16:colId xmlns:a16="http://schemas.microsoft.com/office/drawing/2014/main" val="214209919"/>
                    </a:ext>
                  </a:extLst>
                </a:gridCol>
                <a:gridCol w="2122998">
                  <a:extLst>
                    <a:ext uri="{9D8B030D-6E8A-4147-A177-3AD203B41FA5}">
                      <a16:colId xmlns:a16="http://schemas.microsoft.com/office/drawing/2014/main" val="1305851498"/>
                    </a:ext>
                  </a:extLst>
                </a:gridCol>
              </a:tblGrid>
              <a:tr h="364946"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D4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D18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D35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D56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5264610"/>
                  </a:ext>
                </a:extLst>
              </a:tr>
              <a:tr h="761567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tical Allograft</a:t>
                      </a:r>
                    </a:p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2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8125496"/>
                  </a:ext>
                </a:extLst>
              </a:tr>
              <a:tr h="652150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tical Allograft</a:t>
                      </a:r>
                    </a:p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rile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3384016"/>
                  </a:ext>
                </a:extLst>
              </a:tr>
              <a:tr h="729643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inless Steel Disc</a:t>
                      </a:r>
                    </a:p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2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5918496"/>
                  </a:ext>
                </a:extLst>
              </a:tr>
              <a:tr h="669831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inless Steel Disc </a:t>
                      </a:r>
                    </a:p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rile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8441698"/>
                  </a:ext>
                </a:extLst>
              </a:tr>
              <a:tr h="711395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llous Allograft 1e2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1372138"/>
                  </a:ext>
                </a:extLst>
              </a:tr>
              <a:tr h="696756"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llous Allograft Sterile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003678"/>
                  </a:ext>
                </a:extLst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98727" y="827348"/>
            <a:ext cx="623876" cy="61121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95110" y="827348"/>
            <a:ext cx="620458" cy="61121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93871" y="1477077"/>
            <a:ext cx="623876" cy="61414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95111" y="1477079"/>
            <a:ext cx="620459" cy="61414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80285" y="827348"/>
            <a:ext cx="623876" cy="61121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66878" y="1477078"/>
            <a:ext cx="623876" cy="61414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1641" y="827348"/>
            <a:ext cx="627122" cy="61121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84385" y="1477079"/>
            <a:ext cx="620356" cy="61414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090610" y="4977569"/>
            <a:ext cx="9491355" cy="58477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7.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Ex vivo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croscopic analysis of specimens. 1*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FU and sterile control specimens were compared at POD4, POD 18, POD 35, and POD 56. Cortical A</a:t>
            </a:r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llograf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: Infected specimens demonstrated vascular infiltration and gross capsule formation. Sterile specimens did not demonstrate vascular infiltration, erythema, or gross capsule formation. Stainless Steel </a:t>
            </a:r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Dis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: Infected specimens did not visually differ in appearance from sterile specimens at any time point with regards to erythema or absence of capsule formation. Cancellous Allograft: Infected specimens demonstrated modest increased vascularity and erythema at POD18 that resolved and did not visually differ from sterile specimens by POD35 or POD56.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657103" y="1477079"/>
            <a:ext cx="620356" cy="62035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08250" y="1486212"/>
            <a:ext cx="608247" cy="61414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626285" y="827348"/>
            <a:ext cx="622671" cy="61121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1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06070" y="827348"/>
            <a:ext cx="611211" cy="611211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1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5102" y="829382"/>
            <a:ext cx="616420" cy="609828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1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5102" y="1477078"/>
            <a:ext cx="616420" cy="623817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85692" y="827347"/>
            <a:ext cx="576484" cy="614148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92710" y="1481399"/>
            <a:ext cx="571714" cy="61121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3262602-A1B3-4CE1-A68B-5DF889E80B29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5102" y="2157448"/>
            <a:ext cx="609515" cy="666479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C389CF00-71F6-4D33-951A-8296D871B143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47392" y="2154193"/>
            <a:ext cx="596286" cy="66647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11844D48-D26D-4279-A8C3-5B4B5E267650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91952" y="2158296"/>
            <a:ext cx="618947" cy="66756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445ADFE-E740-4600-BD4E-30DB4D38FE01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71113" y="2162580"/>
            <a:ext cx="612658" cy="66077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FA6DFEB1-C4CC-4EA4-8CBC-D2FA7B932323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98281" y="2158298"/>
            <a:ext cx="612070" cy="65987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1FF9C16-1691-4E67-B8FE-8653068E6E72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5216" y="2162579"/>
            <a:ext cx="617379" cy="656963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353A9DF-8C03-47C9-8017-7947199649A8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647933" y="2181206"/>
            <a:ext cx="607686" cy="644302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8CACB7B7-56E1-4CE6-9AD2-199C27F99822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96900" y="2162580"/>
            <a:ext cx="603893" cy="65185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484B9E3-788E-4023-AD9F-9A0883075ABC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5102" y="2881864"/>
            <a:ext cx="603850" cy="609829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4A1D67B-6107-4398-B9A4-AE0DC968000F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47392" y="2881864"/>
            <a:ext cx="596286" cy="61546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0C4CD381-FBAF-4F5D-A3C6-70D4F34F73EB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91899" y="2881864"/>
            <a:ext cx="623876" cy="63718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E000F25F-C7D4-426D-99BC-DFD596657720}"/>
              </a:ext>
            </a:extLst>
          </p:cNvPr>
          <p:cNvPicPr>
            <a:picLocks noChangeAspect="1"/>
          </p:cNvPicPr>
          <p:nvPr/>
        </p:nvPicPr>
        <p:blipFill rotWithShape="1">
          <a:blip r:embed="rId3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85581" y="2886954"/>
            <a:ext cx="602823" cy="637247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9BF6376-F1CE-4D6F-A78C-BAB43F9B9B78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18829" y="2881865"/>
            <a:ext cx="590401" cy="637184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D996A1C4-E65E-4BE2-BC77-92BC337B7799}"/>
              </a:ext>
            </a:extLst>
          </p:cNvPr>
          <p:cNvPicPr>
            <a:picLocks noChangeAspect="1"/>
          </p:cNvPicPr>
          <p:nvPr/>
        </p:nvPicPr>
        <p:blipFill rotWithShape="1">
          <a:blip r:embed="rId3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5216" y="2881864"/>
            <a:ext cx="604559" cy="64018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4D397C9-47FF-4AAE-BCE7-F873A1FEF900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651735" y="2892969"/>
            <a:ext cx="596597" cy="62963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8EC8B5F-7363-41E5-B45D-E809D6441242}"/>
              </a:ext>
            </a:extLst>
          </p:cNvPr>
          <p:cNvPicPr>
            <a:picLocks noChangeAspect="1"/>
          </p:cNvPicPr>
          <p:nvPr/>
        </p:nvPicPr>
        <p:blipFill rotWithShape="1">
          <a:blip r:embed="rId3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96900" y="2892969"/>
            <a:ext cx="600263" cy="62963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D7A54123-9474-4D63-80C1-D63D6D1EA48D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5102" y="3547378"/>
            <a:ext cx="593556" cy="654302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2B4477AD-0241-477B-AF93-4CED43D8A673}"/>
              </a:ext>
            </a:extLst>
          </p:cNvPr>
          <p:cNvPicPr>
            <a:picLocks noChangeAspect="1"/>
          </p:cNvPicPr>
          <p:nvPr/>
        </p:nvPicPr>
        <p:blipFill rotWithShape="1">
          <a:blip r:embed="rId3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52934" y="3548072"/>
            <a:ext cx="584986" cy="654301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E4CA4ABC-F663-4FED-BED8-BB66B130A8C9}"/>
              </a:ext>
            </a:extLst>
          </p:cNvPr>
          <p:cNvPicPr>
            <a:picLocks noChangeAspect="1"/>
          </p:cNvPicPr>
          <p:nvPr/>
        </p:nvPicPr>
        <p:blipFill rotWithShape="1">
          <a:blip r:embed="rId3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91611" y="3547660"/>
            <a:ext cx="588957" cy="654302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97D92ECD-134C-42E0-AE44-7D4DF4EDA39B}"/>
              </a:ext>
            </a:extLst>
          </p:cNvPr>
          <p:cNvPicPr>
            <a:picLocks noChangeAspect="1"/>
          </p:cNvPicPr>
          <p:nvPr/>
        </p:nvPicPr>
        <p:blipFill rotWithShape="1">
          <a:blip r:embed="rId3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68979" y="3547378"/>
            <a:ext cx="607644" cy="656914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7265F02B-BEF1-412C-870E-3402D30BD41F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29527" y="3547377"/>
            <a:ext cx="587437" cy="656915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CB21551-F59F-4410-B49D-C8B8692D9B8A}"/>
              </a:ext>
            </a:extLst>
          </p:cNvPr>
          <p:cNvPicPr>
            <a:picLocks noChangeAspect="1"/>
          </p:cNvPicPr>
          <p:nvPr/>
        </p:nvPicPr>
        <p:blipFill rotWithShape="1">
          <a:blip r:embed="rId4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80625" y="3547375"/>
            <a:ext cx="588957" cy="6543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EF432D18-41B4-4B55-ACA1-5A2A1DC871C4}"/>
              </a:ext>
            </a:extLst>
          </p:cNvPr>
          <p:cNvPicPr>
            <a:picLocks noChangeAspect="1"/>
          </p:cNvPicPr>
          <p:nvPr/>
        </p:nvPicPr>
        <p:blipFill rotWithShape="1">
          <a:blip r:embed="rId4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8603061" y="3580206"/>
            <a:ext cx="656918" cy="59126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68839FE9-89DB-46F8-A598-3A5E53150058}"/>
              </a:ext>
            </a:extLst>
          </p:cNvPr>
          <p:cNvPicPr>
            <a:picLocks noChangeAspect="1"/>
          </p:cNvPicPr>
          <p:nvPr/>
        </p:nvPicPr>
        <p:blipFill rotWithShape="1">
          <a:blip r:embed="rId4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77441" y="3543531"/>
            <a:ext cx="585064" cy="656916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B484E69-9317-4DAE-AB34-7C6E6ECD2E38}"/>
              </a:ext>
            </a:extLst>
          </p:cNvPr>
          <p:cNvPicPr>
            <a:picLocks noChangeAspect="1"/>
          </p:cNvPicPr>
          <p:nvPr/>
        </p:nvPicPr>
        <p:blipFill rotWithShape="1">
          <a:blip r:embed="rId4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5102" y="4261477"/>
            <a:ext cx="584357" cy="656916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C1509A18-9520-4994-BD93-8261333A1D77}"/>
              </a:ext>
            </a:extLst>
          </p:cNvPr>
          <p:cNvPicPr>
            <a:picLocks noChangeAspect="1"/>
          </p:cNvPicPr>
          <p:nvPr/>
        </p:nvPicPr>
        <p:blipFill rotWithShape="1">
          <a:blip r:embed="rId4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53930" y="4261475"/>
            <a:ext cx="579758" cy="657356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4C413250-16C4-4F31-8464-0D71F55F3CF9}"/>
              </a:ext>
            </a:extLst>
          </p:cNvPr>
          <p:cNvPicPr>
            <a:picLocks noChangeAspect="1"/>
          </p:cNvPicPr>
          <p:nvPr/>
        </p:nvPicPr>
        <p:blipFill rotWithShape="1">
          <a:blip r:embed="rId4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84348" y="4257630"/>
            <a:ext cx="588957" cy="65953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C24EA0D-E64D-4353-B657-44BDC98D3121}"/>
              </a:ext>
            </a:extLst>
          </p:cNvPr>
          <p:cNvPicPr>
            <a:picLocks noChangeAspect="1"/>
          </p:cNvPicPr>
          <p:nvPr/>
        </p:nvPicPr>
        <p:blipFill rotWithShape="1">
          <a:blip r:embed="rId4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61720" y="4261475"/>
            <a:ext cx="600902" cy="659531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E50AD0F9-34A3-4F32-8B76-B8216F201F37}"/>
              </a:ext>
            </a:extLst>
          </p:cNvPr>
          <p:cNvPicPr>
            <a:picLocks noChangeAspect="1"/>
          </p:cNvPicPr>
          <p:nvPr/>
        </p:nvPicPr>
        <p:blipFill rotWithShape="1">
          <a:blip r:embed="rId4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22265" y="4261470"/>
            <a:ext cx="587436" cy="659534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F35BA703-83A6-4C73-A964-C13BDC0F0D87}"/>
              </a:ext>
            </a:extLst>
          </p:cNvPr>
          <p:cNvPicPr>
            <a:picLocks noChangeAspect="1"/>
          </p:cNvPicPr>
          <p:nvPr/>
        </p:nvPicPr>
        <p:blipFill rotWithShape="1">
          <a:blip r:embed="rId4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73363" y="4257624"/>
            <a:ext cx="588957" cy="659533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7824BCF6-E3DF-42B2-B0CA-C10C3A888198}"/>
              </a:ext>
            </a:extLst>
          </p:cNvPr>
          <p:cNvPicPr>
            <a:picLocks noChangeAspect="1"/>
          </p:cNvPicPr>
          <p:nvPr/>
        </p:nvPicPr>
        <p:blipFill rotWithShape="1">
          <a:blip r:embed="rId4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8584081" y="4290786"/>
            <a:ext cx="659534" cy="600901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6E43A75D-EC9F-4D9A-BF91-A2094F0C2FBD}"/>
              </a:ext>
            </a:extLst>
          </p:cNvPr>
          <p:cNvPicPr>
            <a:picLocks noChangeAspect="1"/>
          </p:cNvPicPr>
          <p:nvPr/>
        </p:nvPicPr>
        <p:blipFill rotWithShape="1">
          <a:blip r:embed="rId5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67437" y="4257625"/>
            <a:ext cx="579321" cy="659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5993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1</Words>
  <Application>Microsoft Office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2</cp:revision>
  <dcterms:created xsi:type="dcterms:W3CDTF">2020-05-15T00:06:30Z</dcterms:created>
  <dcterms:modified xsi:type="dcterms:W3CDTF">2020-08-22T04:24:22Z</dcterms:modified>
</cp:coreProperties>
</file>